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2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78" y="2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416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2735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5830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9069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2812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9869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1949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1173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8284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2132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004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CC5A06-C00C-4991-B455-06A799410CA4}" type="datetimeFigureOut">
              <a:rPr lang="fr-FR" smtClean="0"/>
              <a:t>27/02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13A5B-1CE9-4CF5-9058-D615409499C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0152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e 9"/>
          <p:cNvGrpSpPr/>
          <p:nvPr/>
        </p:nvGrpSpPr>
        <p:grpSpPr>
          <a:xfrm>
            <a:off x="1937326" y="616901"/>
            <a:ext cx="4140877" cy="3715293"/>
            <a:chOff x="2146593" y="616900"/>
            <a:chExt cx="4140877" cy="3715293"/>
          </a:xfrm>
        </p:grpSpPr>
        <p:pic>
          <p:nvPicPr>
            <p:cNvPr id="2" name="Image 1"/>
            <p:cNvPicPr/>
            <p:nvPr/>
          </p:nvPicPr>
          <p:blipFill>
            <a:blip r:embed="rId2" cstate="print"/>
            <a:srcRect l="1006" t="77776" r="67314" b="9603"/>
            <a:stretch>
              <a:fillRect/>
            </a:stretch>
          </p:blipFill>
          <p:spPr bwMode="auto">
            <a:xfrm>
              <a:off x="2170898" y="967153"/>
              <a:ext cx="3855720" cy="863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" name="ZoneTexte 2"/>
            <p:cNvSpPr txBox="1"/>
            <p:nvPr/>
          </p:nvSpPr>
          <p:spPr>
            <a:xfrm>
              <a:off x="2630795" y="616900"/>
              <a:ext cx="33343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E.coli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RPuL2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11.31 Net charge at pH7=33.8</a:t>
              </a:r>
            </a:p>
          </p:txBody>
        </p:sp>
        <p:pic>
          <p:nvPicPr>
            <p:cNvPr id="4" name="Image 3"/>
            <p:cNvPicPr/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203283" y="2292799"/>
              <a:ext cx="3790950" cy="9150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" name="ZoneTexte 4"/>
            <p:cNvSpPr txBox="1"/>
            <p:nvPr/>
          </p:nvSpPr>
          <p:spPr>
            <a:xfrm>
              <a:off x="2732811" y="1915744"/>
              <a:ext cx="29684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tRPuL2A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11.1 Net charge at pH7=29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3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299486" y="3463513"/>
              <a:ext cx="3598545" cy="868680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2146593" y="3158402"/>
              <a:ext cx="41408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trunA17Chr8g0347691 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=9.45 Net charge at pH7=7.7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" name="ZoneTexte 8"/>
          <p:cNvSpPr txBox="1"/>
          <p:nvPr/>
        </p:nvSpPr>
        <p:spPr>
          <a:xfrm>
            <a:off x="3608809" y="5503541"/>
            <a:ext cx="83348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/>
            <a:r>
              <a:rPr lang="es-A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 </a:t>
            </a:r>
            <a:r>
              <a:rPr lang="es-AR" sz="10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s-AR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s-A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tulated</a:t>
            </a:r>
            <a:r>
              <a:rPr lang="es-A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A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de</a:t>
            </a:r>
            <a:r>
              <a:rPr lang="es-A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s-A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ognition</a:t>
            </a:r>
            <a:r>
              <a:rPr lang="es-A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AR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es-A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tRPuL2A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0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liloti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srA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5"/>
          <a:srcRect l="44328" t="29030" r="24403" b="48425"/>
          <a:stretch/>
        </p:blipFill>
        <p:spPr>
          <a:xfrm>
            <a:off x="6078203" y="967153"/>
            <a:ext cx="4094329" cy="2977050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1937325" y="48027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 </a:t>
            </a:r>
          </a:p>
        </p:txBody>
      </p:sp>
      <p:sp>
        <p:nvSpPr>
          <p:cNvPr id="14" name="ZoneTexte 13"/>
          <p:cNvSpPr txBox="1"/>
          <p:nvPr/>
        </p:nvSpPr>
        <p:spPr>
          <a:xfrm>
            <a:off x="6104770" y="48027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076225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Grand écran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batut</dc:creator>
  <cp:lastModifiedBy>jbatut</cp:lastModifiedBy>
  <cp:revision>1</cp:revision>
  <dcterms:created xsi:type="dcterms:W3CDTF">2020-02-27T11:39:37Z</dcterms:created>
  <dcterms:modified xsi:type="dcterms:W3CDTF">2020-02-27T11:40:03Z</dcterms:modified>
</cp:coreProperties>
</file>